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1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539"/>
    <p:restoredTop sz="99306" autoAdjust="0"/>
  </p:normalViewPr>
  <p:slideViewPr>
    <p:cSldViewPr snapToGrid="0">
      <p:cViewPr varScale="1">
        <p:scale>
          <a:sx n="146" d="100"/>
          <a:sy n="146" d="100"/>
        </p:scale>
        <p:origin x="1696" y="17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file:////Volumes/group09/Carrie/Breast%20Cancer%20project/Carrie's%20Data/Spheroid%20forming%20assay/celligo%20combined%20summary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microsoft.com/office/2011/relationships/chartStyle" Target="style2.xml"/><Relationship Id="rId2" Type="http://schemas.microsoft.com/office/2011/relationships/chartColorStyle" Target="colors2.xml"/><Relationship Id="rId3" Type="http://schemas.openxmlformats.org/officeDocument/2006/relationships/oleObject" Target="file:////Volumes/group09/Carrie/Breast%20Cancer%20project/Carrie's%20Data/Spheroid%20forming%20assay/celligo%20combined%20summary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microsoft.com/office/2011/relationships/chartStyle" Target="style3.xml"/><Relationship Id="rId2" Type="http://schemas.microsoft.com/office/2011/relationships/chartColorStyle" Target="colors3.xml"/><Relationship Id="rId3" Type="http://schemas.openxmlformats.org/officeDocument/2006/relationships/oleObject" Target="file:////Volumes/group09/Carrie/Breast%20Cancer%20project/Carrie's%20Data/Spheroid%20forming%20assay/celligo%20combined%20summar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 dirty="0"/>
              <a:t>MDA 231</a:t>
            </a:r>
          </a:p>
        </c:rich>
      </c:tx>
      <c:layout>
        <c:manualLayout>
          <c:xMode val="edge"/>
          <c:yMode val="edge"/>
          <c:x val="0.453788542452943"/>
          <c:y val="0.091506734030994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DA231'!$W$28:$W$31</c:f>
                <c:numCache>
                  <c:formatCode>General</c:formatCode>
                  <c:ptCount val="4"/>
                  <c:pt idx="0">
                    <c:v>0.0572424706884917</c:v>
                  </c:pt>
                  <c:pt idx="1">
                    <c:v>0.152244373013648</c:v>
                  </c:pt>
                  <c:pt idx="2">
                    <c:v>0.0517322471638726</c:v>
                  </c:pt>
                  <c:pt idx="3">
                    <c:v>0.0208597273681979</c:v>
                  </c:pt>
                </c:numCache>
              </c:numRef>
            </c:plus>
            <c:minus>
              <c:numRef>
                <c:f>'MDA231'!$W$28:$W$31</c:f>
                <c:numCache>
                  <c:formatCode>General</c:formatCode>
                  <c:ptCount val="4"/>
                  <c:pt idx="0">
                    <c:v>0.0572424706884917</c:v>
                  </c:pt>
                  <c:pt idx="1">
                    <c:v>0.152244373013648</c:v>
                  </c:pt>
                  <c:pt idx="2">
                    <c:v>0.0517322471638726</c:v>
                  </c:pt>
                  <c:pt idx="3">
                    <c:v>0.020859727368197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MDA231'!$T$28:$T$31</c:f>
              <c:strCache>
                <c:ptCount val="4"/>
                <c:pt idx="0">
                  <c:v>shNeg siNeg</c:v>
                </c:pt>
                <c:pt idx="1">
                  <c:v>shIKKe siNeg</c:v>
                </c:pt>
                <c:pt idx="2">
                  <c:v>shNeg sip52</c:v>
                </c:pt>
                <c:pt idx="3">
                  <c:v>shIKKe sip52</c:v>
                </c:pt>
              </c:strCache>
            </c:strRef>
          </c:cat>
          <c:val>
            <c:numRef>
              <c:f>'MDA231'!$U$28:$U$31</c:f>
              <c:numCache>
                <c:formatCode>General</c:formatCode>
                <c:ptCount val="4"/>
                <c:pt idx="0">
                  <c:v>1.0</c:v>
                </c:pt>
                <c:pt idx="1">
                  <c:v>1.136363636363636</c:v>
                </c:pt>
                <c:pt idx="2">
                  <c:v>0.630681818181818</c:v>
                </c:pt>
                <c:pt idx="3">
                  <c:v>0.56818181818181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AE4-4F40-BFD7-B9105F0700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414991792"/>
        <c:axId val="-414801440"/>
      </c:barChart>
      <c:catAx>
        <c:axId val="-41499179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414801440"/>
        <c:crosses val="autoZero"/>
        <c:auto val="1"/>
        <c:lblAlgn val="ctr"/>
        <c:lblOffset val="100"/>
        <c:noMultiLvlLbl val="0"/>
      </c:catAx>
      <c:valAx>
        <c:axId val="-4148014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Spheroid formation efficiency (relative to negative control)</a:t>
                </a:r>
              </a:p>
            </c:rich>
          </c:tx>
          <c:layout>
            <c:manualLayout>
              <c:xMode val="edge"/>
              <c:yMode val="edge"/>
              <c:x val="0.0166666666666667"/>
              <c:y val="0.13930555555555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4149917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MDA231</a:t>
            </a:r>
          </a:p>
        </c:rich>
      </c:tx>
      <c:layout>
        <c:manualLayout>
          <c:xMode val="edge"/>
          <c:yMode val="edge"/>
          <c:x val="0.478590502541155"/>
          <c:y val="0.083456664258721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49638254245828"/>
          <c:y val="0.194632863431946"/>
          <c:w val="0.69814384497704"/>
          <c:h val="0.70402690139674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DA231'!$W$33:$W$36</c:f>
                <c:numCache>
                  <c:formatCode>General</c:formatCode>
                  <c:ptCount val="4"/>
                  <c:pt idx="0">
                    <c:v>0.0757267078545698</c:v>
                  </c:pt>
                  <c:pt idx="1">
                    <c:v>0.115094810335906</c:v>
                  </c:pt>
                  <c:pt idx="2">
                    <c:v>0.132644207308504</c:v>
                  </c:pt>
                  <c:pt idx="3">
                    <c:v>0.194780853443959</c:v>
                  </c:pt>
                </c:numCache>
              </c:numRef>
            </c:plus>
            <c:minus>
              <c:numRef>
                <c:f>'MDA231'!$W$33:$W$36</c:f>
                <c:numCache>
                  <c:formatCode>General</c:formatCode>
                  <c:ptCount val="4"/>
                  <c:pt idx="0">
                    <c:v>0.0757267078545698</c:v>
                  </c:pt>
                  <c:pt idx="1">
                    <c:v>0.115094810335906</c:v>
                  </c:pt>
                  <c:pt idx="2">
                    <c:v>0.132644207308504</c:v>
                  </c:pt>
                  <c:pt idx="3">
                    <c:v>0.1947808534439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MDA231'!$T$33:$T$36</c:f>
              <c:strCache>
                <c:ptCount val="4"/>
                <c:pt idx="0">
                  <c:v>shNeg vehicle</c:v>
                </c:pt>
                <c:pt idx="1">
                  <c:v>shIKKe vehicle</c:v>
                </c:pt>
                <c:pt idx="2">
                  <c:v>shNeg MEKi</c:v>
                </c:pt>
                <c:pt idx="3">
                  <c:v>shIKKe MEKi</c:v>
                </c:pt>
              </c:strCache>
            </c:strRef>
          </c:cat>
          <c:val>
            <c:numRef>
              <c:f>'MDA231'!$U$33:$U$36</c:f>
              <c:numCache>
                <c:formatCode>General</c:formatCode>
                <c:ptCount val="4"/>
                <c:pt idx="0">
                  <c:v>1.0</c:v>
                </c:pt>
                <c:pt idx="1">
                  <c:v>1.78409090909091</c:v>
                </c:pt>
                <c:pt idx="2">
                  <c:v>1.011363636363636</c:v>
                </c:pt>
                <c:pt idx="3">
                  <c:v>1.85227272727272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E5A-C64E-9A6A-3328B424D3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545095472"/>
        <c:axId val="-544484896"/>
      </c:barChart>
      <c:catAx>
        <c:axId val="-54509547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544484896"/>
        <c:crosses val="autoZero"/>
        <c:auto val="1"/>
        <c:lblAlgn val="ctr"/>
        <c:lblOffset val="100"/>
        <c:noMultiLvlLbl val="0"/>
      </c:catAx>
      <c:valAx>
        <c:axId val="-5444848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Spheroid formation efficiency (relative to vehicle control)</a:t>
                </a:r>
              </a:p>
            </c:rich>
          </c:tx>
          <c:layout>
            <c:manualLayout>
              <c:xMode val="edge"/>
              <c:yMode val="edge"/>
              <c:x val="0.0299727520435967"/>
              <c:y val="0.1044796380090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5450954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02839960463635"/>
          <c:y val="0.0888924304676517"/>
          <c:w val="0.644211841538968"/>
          <c:h val="0.84133694695484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DA468'!$W$28:$W$31</c:f>
                <c:numCache>
                  <c:formatCode>General</c:formatCode>
                  <c:ptCount val="4"/>
                  <c:pt idx="0">
                    <c:v>0.0964494006662261</c:v>
                  </c:pt>
                  <c:pt idx="1">
                    <c:v>0.0628834250232914</c:v>
                  </c:pt>
                  <c:pt idx="2">
                    <c:v>0.0791042981091502</c:v>
                  </c:pt>
                  <c:pt idx="3">
                    <c:v>0.0542419882221913</c:v>
                  </c:pt>
                </c:numCache>
              </c:numRef>
            </c:plus>
            <c:minus>
              <c:numRef>
                <c:f>'MDA468'!$W$28:$W$31</c:f>
                <c:numCache>
                  <c:formatCode>General</c:formatCode>
                  <c:ptCount val="4"/>
                  <c:pt idx="0">
                    <c:v>0.0964494006662261</c:v>
                  </c:pt>
                  <c:pt idx="1">
                    <c:v>0.0628834250232914</c:v>
                  </c:pt>
                  <c:pt idx="2">
                    <c:v>0.0791042981091502</c:v>
                  </c:pt>
                  <c:pt idx="3">
                    <c:v>0.05424198822219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MDA468'!$T$28:$T$31</c:f>
              <c:strCache>
                <c:ptCount val="4"/>
                <c:pt idx="0">
                  <c:v>shNeg siNeg</c:v>
                </c:pt>
                <c:pt idx="1">
                  <c:v>shIKKe siNeg</c:v>
                </c:pt>
                <c:pt idx="2">
                  <c:v>shNeg sip52</c:v>
                </c:pt>
                <c:pt idx="3">
                  <c:v>shIKKe sip52</c:v>
                </c:pt>
              </c:strCache>
            </c:strRef>
          </c:cat>
          <c:val>
            <c:numRef>
              <c:f>'MDA468'!$U$28:$U$31</c:f>
              <c:numCache>
                <c:formatCode>General</c:formatCode>
                <c:ptCount val="4"/>
                <c:pt idx="0">
                  <c:v>1.0</c:v>
                </c:pt>
                <c:pt idx="1">
                  <c:v>0.736059479553903</c:v>
                </c:pt>
                <c:pt idx="2">
                  <c:v>0.925650557620818</c:v>
                </c:pt>
                <c:pt idx="3">
                  <c:v>0.5836431226765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0EF-0F43-A5E6-75FBA60138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878932000"/>
        <c:axId val="-879375152"/>
      </c:barChart>
      <c:catAx>
        <c:axId val="-87893200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879375152"/>
        <c:crosses val="autoZero"/>
        <c:auto val="1"/>
        <c:lblAlgn val="ctr"/>
        <c:lblOffset val="100"/>
        <c:noMultiLvlLbl val="0"/>
      </c:catAx>
      <c:valAx>
        <c:axId val="-8793751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Spheroid formation efficiency (relative to negative control)</a:t>
                </a:r>
              </a:p>
            </c:rich>
          </c:tx>
          <c:layout>
            <c:manualLayout>
              <c:xMode val="edge"/>
              <c:yMode val="edge"/>
              <c:x val="0.0277777777777778"/>
              <c:y val="0.15319444444444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8789320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3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2906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158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0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0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14978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233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4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843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10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261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251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287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4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433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603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6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0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313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4" Type="http://schemas.openxmlformats.org/officeDocument/2006/relationships/image" Target="../media/image2.emf"/><Relationship Id="rId5" Type="http://schemas.openxmlformats.org/officeDocument/2006/relationships/image" Target="../media/image3.emf"/><Relationship Id="rId6" Type="http://schemas.openxmlformats.org/officeDocument/2006/relationships/image" Target="../media/image4.emf"/><Relationship Id="rId7" Type="http://schemas.openxmlformats.org/officeDocument/2006/relationships/chart" Target="../charts/chart2.xml"/><Relationship Id="rId8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68734" y="3421637"/>
            <a:ext cx="3332041" cy="2122715"/>
            <a:chOff x="3462291" y="363983"/>
            <a:chExt cx="3266982" cy="2197223"/>
          </a:xfrm>
        </p:grpSpPr>
        <p:graphicFrame>
          <p:nvGraphicFramePr>
            <p:cNvPr id="3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42955216"/>
                </p:ext>
              </p:extLst>
            </p:nvPr>
          </p:nvGraphicFramePr>
          <p:xfrm>
            <a:off x="3462291" y="363983"/>
            <a:ext cx="3266982" cy="219722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TextBox 3"/>
            <p:cNvSpPr txBox="1"/>
            <p:nvPr/>
          </p:nvSpPr>
          <p:spPr>
            <a:xfrm>
              <a:off x="5571108" y="1376614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*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6151279" y="1455757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*</a:t>
              </a:r>
            </a:p>
          </p:txBody>
        </p:sp>
      </p:grpSp>
      <p:grpSp>
        <p:nvGrpSpPr>
          <p:cNvPr id="97" name="Group 96"/>
          <p:cNvGrpSpPr/>
          <p:nvPr/>
        </p:nvGrpSpPr>
        <p:grpSpPr>
          <a:xfrm>
            <a:off x="3312357" y="3792201"/>
            <a:ext cx="1882419" cy="1612183"/>
            <a:chOff x="963669" y="7300085"/>
            <a:chExt cx="1882419" cy="1612183"/>
          </a:xfrm>
        </p:grpSpPr>
        <p:sp>
          <p:nvSpPr>
            <p:cNvPr id="6" name="TextBox 5"/>
            <p:cNvSpPr txBox="1"/>
            <p:nvPr/>
          </p:nvSpPr>
          <p:spPr>
            <a:xfrm>
              <a:off x="1473515" y="7300085"/>
              <a:ext cx="6046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shNeg</a:t>
              </a:r>
              <a:r>
                <a:rPr lang="en-US" sz="1000" dirty="0"/>
                <a:t> 1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199385" y="7300085"/>
              <a:ext cx="6206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shIKK</a:t>
              </a:r>
              <a:r>
                <a:rPr lang="en-US" sz="1000" dirty="0" err="1">
                  <a:latin typeface="Symbol" charset="2"/>
                  <a:ea typeface="Symbol" charset="2"/>
                  <a:cs typeface="Symbol" charset="2"/>
                </a:rPr>
                <a:t>e</a:t>
              </a:r>
              <a:r>
                <a:rPr lang="en-US" sz="1000" dirty="0">
                  <a:latin typeface="Symbol" charset="2"/>
                  <a:ea typeface="Symbol" charset="2"/>
                  <a:cs typeface="Symbol" charset="2"/>
                </a:rPr>
                <a:t> 1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963669" y="7706566"/>
              <a:ext cx="4716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siNeg</a:t>
              </a:r>
              <a:endParaRPr lang="en-US" sz="10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973287" y="8508102"/>
              <a:ext cx="4619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ip52</a:t>
              </a:r>
            </a:p>
          </p:txBody>
        </p:sp>
        <p:grpSp>
          <p:nvGrpSpPr>
            <p:cNvPr id="10" name="Group 9"/>
            <p:cNvGrpSpPr/>
            <p:nvPr/>
          </p:nvGrpSpPr>
          <p:grpSpPr>
            <a:xfrm>
              <a:off x="1375934" y="7510563"/>
              <a:ext cx="1470154" cy="1401705"/>
              <a:chOff x="4245075" y="6165516"/>
              <a:chExt cx="1981273" cy="2092058"/>
            </a:xfrm>
          </p:grpSpPr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xmlns="" id="{F47BCB6D-DAA6-424B-9553-E50F3CB500F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6528" t="12998" r="8045"/>
              <a:stretch/>
            </p:blipFill>
            <p:spPr>
              <a:xfrm>
                <a:off x="4249352" y="6166659"/>
                <a:ext cx="962975" cy="1022751"/>
              </a:xfrm>
              <a:prstGeom prst="rect">
                <a:avLst/>
              </a:prstGeom>
            </p:spPr>
          </p:pic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xmlns="" id="{8EB79206-4CF0-4E7C-BF62-A0993541491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752" t="750" r="12742" b="12357"/>
              <a:stretch/>
            </p:blipFill>
            <p:spPr>
              <a:xfrm>
                <a:off x="5253856" y="6165516"/>
                <a:ext cx="972491" cy="1020652"/>
              </a:xfrm>
              <a:prstGeom prst="rect">
                <a:avLst/>
              </a:prstGeom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xmlns="" id="{C405E030-A374-4818-86A7-3674EBF24CE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7287" t="4589" r="7287" b="4407"/>
              <a:stretch/>
            </p:blipFill>
            <p:spPr>
              <a:xfrm>
                <a:off x="4245075" y="7233048"/>
                <a:ext cx="972489" cy="1024526"/>
              </a:xfrm>
              <a:prstGeom prst="rect">
                <a:avLst/>
              </a:prstGeom>
            </p:spPr>
          </p:pic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xmlns="" id="{6744D50E-0B1F-4EDD-ABBA-37087BC2B6E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4775" t="8041" r="14772" b="12269"/>
              <a:stretch/>
            </p:blipFill>
            <p:spPr>
              <a:xfrm>
                <a:off x="5253857" y="7233048"/>
                <a:ext cx="972491" cy="1024526"/>
              </a:xfrm>
              <a:prstGeom prst="rect">
                <a:avLst/>
              </a:prstGeom>
            </p:spPr>
          </p:pic>
        </p:grpSp>
        <p:cxnSp>
          <p:nvCxnSpPr>
            <p:cNvPr id="15" name="Straight Connector 14"/>
            <p:cNvCxnSpPr/>
            <p:nvPr/>
          </p:nvCxnSpPr>
          <p:spPr>
            <a:xfrm flipH="1">
              <a:off x="2110874" y="7509504"/>
              <a:ext cx="3209" cy="1402764"/>
            </a:xfrm>
            <a:prstGeom prst="line">
              <a:avLst/>
            </a:prstGeom>
            <a:ln w="476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flipH="1" flipV="1">
              <a:off x="1375934" y="8212862"/>
              <a:ext cx="1463587" cy="1338"/>
            </a:xfrm>
            <a:prstGeom prst="line">
              <a:avLst/>
            </a:prstGeom>
            <a:ln w="476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" name="Group 16"/>
          <p:cNvGrpSpPr/>
          <p:nvPr/>
        </p:nvGrpSpPr>
        <p:grpSpPr>
          <a:xfrm>
            <a:off x="145112" y="5359280"/>
            <a:ext cx="3216367" cy="442116"/>
            <a:chOff x="144887" y="2457383"/>
            <a:chExt cx="2931949" cy="442116"/>
          </a:xfrm>
        </p:grpSpPr>
        <p:sp>
          <p:nvSpPr>
            <p:cNvPr id="18" name="TextBox 17"/>
            <p:cNvSpPr txBox="1"/>
            <p:nvPr/>
          </p:nvSpPr>
          <p:spPr>
            <a:xfrm>
              <a:off x="988311" y="2457383"/>
              <a:ext cx="4876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Neg</a:t>
              </a:r>
              <a:r>
                <a:rPr lang="en-US" sz="1000" dirty="0"/>
                <a:t> 1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062897" y="2653278"/>
              <a:ext cx="3834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52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44887" y="2457383"/>
              <a:ext cx="9076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shRNA</a:t>
              </a:r>
              <a:r>
                <a:rPr lang="en-US" sz="1000" dirty="0"/>
                <a:t> target: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90423" y="2648274"/>
              <a:ext cx="8691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siRNA</a:t>
              </a:r>
              <a:r>
                <a:rPr lang="en-US" sz="1000" dirty="0"/>
                <a:t> target: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988311" y="2653278"/>
              <a:ext cx="3930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Neg</a:t>
              </a:r>
              <a:endParaRPr lang="en-US" sz="10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050762" y="2457383"/>
              <a:ext cx="4876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Neg</a:t>
              </a:r>
              <a:r>
                <a:rPr lang="en-US" sz="1000" dirty="0"/>
                <a:t> 1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525604" y="2653278"/>
              <a:ext cx="3930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Neg</a:t>
              </a:r>
              <a:endParaRPr lang="en-US" sz="1000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509117" y="2457383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IKK</a:t>
              </a:r>
              <a:r>
                <a:rPr lang="en-US" sz="1000" dirty="0" err="1">
                  <a:latin typeface="Symbol" charset="2"/>
                  <a:cs typeface="Symbol" charset="2"/>
                </a:rPr>
                <a:t>e</a:t>
              </a:r>
              <a:r>
                <a:rPr lang="en-US" sz="1000" dirty="0">
                  <a:latin typeface="Symbol" charset="2"/>
                  <a:cs typeface="Symbol" charset="2"/>
                </a:rPr>
                <a:t> </a:t>
              </a:r>
              <a:r>
                <a:rPr lang="en-US" sz="1000" dirty="0">
                  <a:cs typeface="Symbol" charset="2"/>
                </a:rPr>
                <a:t>1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571569" y="2457383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IKK</a:t>
              </a:r>
              <a:r>
                <a:rPr lang="en-US" sz="1000" dirty="0" err="1">
                  <a:latin typeface="Symbol" charset="2"/>
                  <a:cs typeface="Symbol" charset="2"/>
                </a:rPr>
                <a:t>e</a:t>
              </a:r>
              <a:r>
                <a:rPr lang="en-US" sz="1000" dirty="0">
                  <a:latin typeface="Symbol" charset="2"/>
                  <a:cs typeface="Symbol" charset="2"/>
                </a:rPr>
                <a:t> </a:t>
              </a:r>
              <a:r>
                <a:rPr lang="en-US" sz="1000" dirty="0">
                  <a:cs typeface="Symbol" charset="2"/>
                </a:rPr>
                <a:t>1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588969" y="2653278"/>
              <a:ext cx="3834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52</a:t>
              </a:r>
            </a:p>
          </p:txBody>
        </p:sp>
      </p:grpSp>
      <p:graphicFrame>
        <p:nvGraphicFramePr>
          <p:cNvPr id="28" name="Chart 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1178572"/>
              </p:ext>
            </p:extLst>
          </p:nvPr>
        </p:nvGraphicFramePr>
        <p:xfrm>
          <a:off x="199728" y="5999378"/>
          <a:ext cx="3161751" cy="21304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pSp>
        <p:nvGrpSpPr>
          <p:cNvPr id="29" name="Group 28"/>
          <p:cNvGrpSpPr/>
          <p:nvPr/>
        </p:nvGrpSpPr>
        <p:grpSpPr>
          <a:xfrm>
            <a:off x="140698" y="7916305"/>
            <a:ext cx="3101756" cy="358406"/>
            <a:chOff x="3136381" y="2325405"/>
            <a:chExt cx="3179698" cy="447036"/>
          </a:xfrm>
        </p:grpSpPr>
        <p:sp>
          <p:nvSpPr>
            <p:cNvPr id="30" name="TextBox 29"/>
            <p:cNvSpPr txBox="1"/>
            <p:nvPr/>
          </p:nvSpPr>
          <p:spPr>
            <a:xfrm>
              <a:off x="4086149" y="2325405"/>
              <a:ext cx="4876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Neg</a:t>
              </a:r>
              <a:r>
                <a:rPr lang="en-US" sz="1000" dirty="0"/>
                <a:t> 1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234076" y="2526220"/>
              <a:ext cx="4235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MEK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136381" y="2325405"/>
              <a:ext cx="9076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shRNA</a:t>
              </a:r>
              <a:r>
                <a:rPr lang="en-US" sz="1000" dirty="0"/>
                <a:t> target: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253684" y="2526220"/>
              <a:ext cx="8050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drug target: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033235" y="2526220"/>
              <a:ext cx="55015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ehicle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5214591" y="2325405"/>
              <a:ext cx="4876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Neg</a:t>
              </a:r>
              <a:r>
                <a:rPr lang="en-US" sz="1000" dirty="0"/>
                <a:t> 1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4606956" y="2325405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IKK</a:t>
              </a:r>
              <a:r>
                <a:rPr lang="en-US" sz="1000" dirty="0" err="1">
                  <a:latin typeface="Symbol" charset="2"/>
                  <a:cs typeface="Symbol" charset="2"/>
                </a:rPr>
                <a:t>e</a:t>
              </a:r>
              <a:r>
                <a:rPr lang="en-US" sz="1000" dirty="0">
                  <a:latin typeface="Symbol" charset="2"/>
                  <a:cs typeface="Symbol" charset="2"/>
                </a:rPr>
                <a:t> </a:t>
              </a:r>
              <a:r>
                <a:rPr lang="en-US" sz="1000" dirty="0">
                  <a:cs typeface="Symbol" charset="2"/>
                </a:rPr>
                <a:t>1</a:t>
              </a:r>
              <a:endParaRPr lang="en-US" sz="1000" dirty="0">
                <a:latin typeface="Symbol" charset="2"/>
                <a:cs typeface="Symbol" charset="2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810812" y="2325405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IKK</a:t>
              </a:r>
              <a:r>
                <a:rPr lang="en-US" sz="1000" dirty="0" err="1">
                  <a:latin typeface="Symbol" charset="2"/>
                  <a:cs typeface="Symbol" charset="2"/>
                </a:rPr>
                <a:t>e</a:t>
              </a:r>
              <a:r>
                <a:rPr lang="en-US" sz="1000" dirty="0">
                  <a:latin typeface="Symbol" charset="2"/>
                  <a:cs typeface="Symbol" charset="2"/>
                </a:rPr>
                <a:t> </a:t>
              </a:r>
              <a:r>
                <a:rPr lang="en-US" sz="1000" dirty="0">
                  <a:cs typeface="Symbol" charset="2"/>
                </a:rPr>
                <a:t>1</a:t>
              </a:r>
              <a:endParaRPr lang="en-US" sz="1000" dirty="0">
                <a:latin typeface="Symbol" charset="2"/>
                <a:cs typeface="Symbol" charset="2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828212" y="2516793"/>
              <a:ext cx="4235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MEK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4575570" y="2526220"/>
              <a:ext cx="55015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ehicle</a:t>
              </a:r>
            </a:p>
          </p:txBody>
        </p:sp>
      </p:grpSp>
      <p:sp>
        <p:nvSpPr>
          <p:cNvPr id="40" name="TextBox 39"/>
          <p:cNvSpPr txBox="1"/>
          <p:nvPr/>
        </p:nvSpPr>
        <p:spPr>
          <a:xfrm>
            <a:off x="1675968" y="6504355"/>
            <a:ext cx="279899" cy="2973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*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2785032" y="6447863"/>
            <a:ext cx="279899" cy="2973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*</a:t>
            </a:r>
          </a:p>
        </p:txBody>
      </p:sp>
      <p:graphicFrame>
        <p:nvGraphicFramePr>
          <p:cNvPr id="69" name="Chart 6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78908582"/>
              </p:ext>
            </p:extLst>
          </p:nvPr>
        </p:nvGraphicFramePr>
        <p:xfrm>
          <a:off x="137160" y="1174610"/>
          <a:ext cx="3118142" cy="15154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70" name="TextBox 69"/>
          <p:cNvSpPr txBox="1"/>
          <p:nvPr/>
        </p:nvSpPr>
        <p:spPr>
          <a:xfrm>
            <a:off x="2707818" y="1630249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*</a:t>
            </a:r>
          </a:p>
        </p:txBody>
      </p:sp>
      <p:grpSp>
        <p:nvGrpSpPr>
          <p:cNvPr id="71" name="Group 70"/>
          <p:cNvGrpSpPr/>
          <p:nvPr/>
        </p:nvGrpSpPr>
        <p:grpSpPr>
          <a:xfrm>
            <a:off x="206923" y="2577342"/>
            <a:ext cx="2972756" cy="442116"/>
            <a:chOff x="38033" y="4786199"/>
            <a:chExt cx="3032441" cy="442116"/>
          </a:xfrm>
        </p:grpSpPr>
        <p:sp>
          <p:nvSpPr>
            <p:cNvPr id="84" name="TextBox 83"/>
            <p:cNvSpPr txBox="1"/>
            <p:nvPr/>
          </p:nvSpPr>
          <p:spPr>
            <a:xfrm>
              <a:off x="934814" y="4786199"/>
              <a:ext cx="4876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Neg</a:t>
              </a:r>
              <a:r>
                <a:rPr lang="en-US" sz="1000" dirty="0"/>
                <a:t> 2</a:t>
              </a: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2028254" y="4982094"/>
              <a:ext cx="3834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52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38033" y="4786199"/>
              <a:ext cx="9076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shRNA</a:t>
              </a:r>
              <a:r>
                <a:rPr lang="en-US" sz="1000" dirty="0"/>
                <a:t> target:</a:t>
              </a: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83569" y="4977090"/>
              <a:ext cx="8691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siRNA</a:t>
              </a:r>
              <a:r>
                <a:rPr lang="en-US" sz="1000" dirty="0"/>
                <a:t> target:</a:t>
              </a: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934814" y="4982094"/>
              <a:ext cx="3930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Neg</a:t>
              </a:r>
              <a:endParaRPr lang="en-US" sz="1000" dirty="0"/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2016119" y="4786199"/>
              <a:ext cx="4876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Neg</a:t>
              </a:r>
              <a:r>
                <a:rPr lang="en-US" sz="1000" dirty="0"/>
                <a:t> 2</a:t>
              </a: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1481534" y="4982094"/>
              <a:ext cx="3930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Neg</a:t>
              </a:r>
              <a:endParaRPr lang="en-US" sz="1000" dirty="0"/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1465047" y="4786199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IKK</a:t>
              </a:r>
              <a:r>
                <a:rPr lang="en-US" sz="1000" dirty="0" err="1">
                  <a:latin typeface="Symbol" charset="2"/>
                  <a:cs typeface="Symbol" charset="2"/>
                </a:rPr>
                <a:t>e</a:t>
              </a:r>
              <a:r>
                <a:rPr lang="en-US" sz="1000" dirty="0">
                  <a:latin typeface="Symbol" charset="2"/>
                  <a:cs typeface="Symbol" charset="2"/>
                </a:rPr>
                <a:t> </a:t>
              </a:r>
              <a:r>
                <a:rPr lang="en-US" sz="1000" dirty="0">
                  <a:cs typeface="Symbol" charset="2"/>
                </a:rPr>
                <a:t>2</a:t>
              </a: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2565207" y="4786199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IKK</a:t>
              </a:r>
              <a:r>
                <a:rPr lang="en-US" sz="1000" dirty="0" err="1">
                  <a:latin typeface="Symbol" charset="2"/>
                  <a:cs typeface="Symbol" charset="2"/>
                </a:rPr>
                <a:t>e</a:t>
              </a:r>
              <a:r>
                <a:rPr lang="en-US" sz="1000" dirty="0">
                  <a:latin typeface="Symbol" charset="2"/>
                  <a:cs typeface="Symbol" charset="2"/>
                </a:rPr>
                <a:t> </a:t>
              </a:r>
              <a:r>
                <a:rPr lang="en-US" sz="1000" dirty="0">
                  <a:cs typeface="Symbol" charset="2"/>
                </a:rPr>
                <a:t>2</a:t>
              </a: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2582607" y="4982094"/>
              <a:ext cx="3834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52</a:t>
              </a:r>
            </a:p>
          </p:txBody>
        </p:sp>
      </p:grpSp>
      <p:grpSp>
        <p:nvGrpSpPr>
          <p:cNvPr id="72" name="Group 71"/>
          <p:cNvGrpSpPr/>
          <p:nvPr/>
        </p:nvGrpSpPr>
        <p:grpSpPr>
          <a:xfrm>
            <a:off x="3728663" y="1436650"/>
            <a:ext cx="1482135" cy="1577803"/>
            <a:chOff x="4333881" y="7210218"/>
            <a:chExt cx="1414200" cy="1808172"/>
          </a:xfrm>
        </p:grpSpPr>
        <p:grpSp>
          <p:nvGrpSpPr>
            <p:cNvPr id="77" name="Group 76"/>
            <p:cNvGrpSpPr/>
            <p:nvPr/>
          </p:nvGrpSpPr>
          <p:grpSpPr>
            <a:xfrm>
              <a:off x="4333881" y="7210218"/>
              <a:ext cx="1412554" cy="1808172"/>
              <a:chOff x="664450" y="1097669"/>
              <a:chExt cx="7107950" cy="7421735"/>
            </a:xfrm>
          </p:grpSpPr>
          <p:pic>
            <p:nvPicPr>
              <p:cNvPr id="80" name="Picture 79">
                <a:extLst>
                  <a:ext uri="{FF2B5EF4-FFF2-40B4-BE49-F238E27FC236}">
                    <a16:creationId xmlns:a16="http://schemas.microsoft.com/office/drawing/2014/main" xmlns="" id="{F47BCB6D-DAA6-424B-9553-E50F3CB500F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6528" t="12998" r="8045"/>
              <a:stretch/>
            </p:blipFill>
            <p:spPr>
              <a:xfrm>
                <a:off x="664450" y="1104012"/>
                <a:ext cx="3473684" cy="3653216"/>
              </a:xfrm>
              <a:prstGeom prst="rect">
                <a:avLst/>
              </a:prstGeom>
            </p:spPr>
          </p:pic>
          <p:pic>
            <p:nvPicPr>
              <p:cNvPr id="81" name="Picture 80">
                <a:extLst>
                  <a:ext uri="{FF2B5EF4-FFF2-40B4-BE49-F238E27FC236}">
                    <a16:creationId xmlns:a16="http://schemas.microsoft.com/office/drawing/2014/main" xmlns="" id="{8EB79206-4CF0-4E7C-BF62-A0993541491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752" t="750" r="12742" b="12357"/>
              <a:stretch/>
            </p:blipFill>
            <p:spPr>
              <a:xfrm>
                <a:off x="4298707" y="1097669"/>
                <a:ext cx="3473693" cy="3659559"/>
              </a:xfrm>
              <a:prstGeom prst="rect">
                <a:avLst/>
              </a:prstGeom>
            </p:spPr>
          </p:pic>
          <p:pic>
            <p:nvPicPr>
              <p:cNvPr id="82" name="Picture 81">
                <a:extLst>
                  <a:ext uri="{FF2B5EF4-FFF2-40B4-BE49-F238E27FC236}">
                    <a16:creationId xmlns:a16="http://schemas.microsoft.com/office/drawing/2014/main" xmlns="" id="{C405E030-A374-4818-86A7-3674EBF24CE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7287" t="4589" r="7287" b="4407"/>
              <a:stretch/>
            </p:blipFill>
            <p:spPr>
              <a:xfrm>
                <a:off x="664450" y="4859846"/>
                <a:ext cx="3473685" cy="3659558"/>
              </a:xfrm>
              <a:prstGeom prst="rect">
                <a:avLst/>
              </a:prstGeom>
            </p:spPr>
          </p:pic>
          <p:pic>
            <p:nvPicPr>
              <p:cNvPr id="83" name="Picture 82">
                <a:extLst>
                  <a:ext uri="{FF2B5EF4-FFF2-40B4-BE49-F238E27FC236}">
                    <a16:creationId xmlns:a16="http://schemas.microsoft.com/office/drawing/2014/main" xmlns="" id="{6744D50E-0B1F-4EDD-ABBA-37087BC2B6E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4775" t="8041" r="14772" b="12269"/>
              <a:stretch/>
            </p:blipFill>
            <p:spPr>
              <a:xfrm>
                <a:off x="4298707" y="4859845"/>
                <a:ext cx="3473693" cy="3659559"/>
              </a:xfrm>
              <a:prstGeom prst="rect">
                <a:avLst/>
              </a:prstGeom>
            </p:spPr>
          </p:pic>
        </p:grpSp>
        <p:cxnSp>
          <p:nvCxnSpPr>
            <p:cNvPr id="78" name="Straight Connector 77"/>
            <p:cNvCxnSpPr/>
            <p:nvPr/>
          </p:nvCxnSpPr>
          <p:spPr>
            <a:xfrm>
              <a:off x="5035106" y="7210218"/>
              <a:ext cx="1705" cy="1808172"/>
            </a:xfrm>
            <a:prstGeom prst="line">
              <a:avLst/>
            </a:prstGeom>
            <a:ln w="476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/>
            <p:cNvCxnSpPr/>
            <p:nvPr/>
          </p:nvCxnSpPr>
          <p:spPr>
            <a:xfrm flipH="1">
              <a:off x="4333902" y="8112632"/>
              <a:ext cx="1414179" cy="11204"/>
            </a:xfrm>
            <a:prstGeom prst="line">
              <a:avLst/>
            </a:prstGeom>
            <a:ln w="476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3" name="TextBox 72"/>
          <p:cNvSpPr txBox="1"/>
          <p:nvPr/>
        </p:nvSpPr>
        <p:spPr>
          <a:xfrm>
            <a:off x="3874334" y="1210580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shNeg</a:t>
            </a:r>
            <a:r>
              <a:rPr lang="en-US" sz="1000" dirty="0"/>
              <a:t> 2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4485589" y="1204910"/>
            <a:ext cx="6206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shIKK</a:t>
            </a:r>
            <a:r>
              <a:rPr lang="en-US" sz="1000" dirty="0" err="1">
                <a:latin typeface="Symbol" charset="2"/>
                <a:ea typeface="Symbol" charset="2"/>
                <a:cs typeface="Symbol" charset="2"/>
              </a:rPr>
              <a:t>e</a:t>
            </a:r>
            <a:r>
              <a:rPr lang="en-US" sz="1000" dirty="0">
                <a:latin typeface="Symbol" charset="2"/>
                <a:ea typeface="Symbol" charset="2"/>
                <a:cs typeface="Symbol" charset="2"/>
              </a:rPr>
              <a:t> 2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3240078" y="1762697"/>
            <a:ext cx="4716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siNeg</a:t>
            </a:r>
            <a:endParaRPr lang="en-US" sz="1000" dirty="0"/>
          </a:p>
        </p:txBody>
      </p:sp>
      <p:sp>
        <p:nvSpPr>
          <p:cNvPr id="76" name="TextBox 75"/>
          <p:cNvSpPr txBox="1"/>
          <p:nvPr/>
        </p:nvSpPr>
        <p:spPr>
          <a:xfrm>
            <a:off x="3230079" y="2467561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ip52</a:t>
            </a:r>
          </a:p>
        </p:txBody>
      </p:sp>
      <p:sp>
        <p:nvSpPr>
          <p:cNvPr id="99" name="TextBox 98"/>
          <p:cNvSpPr txBox="1"/>
          <p:nvPr/>
        </p:nvSpPr>
        <p:spPr>
          <a:xfrm>
            <a:off x="1707383" y="1030699"/>
            <a:ext cx="7691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DA 468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167899" y="587113"/>
            <a:ext cx="2824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a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167899" y="3338065"/>
            <a:ext cx="2920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167899" y="5862050"/>
            <a:ext cx="2712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54659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56</TotalTime>
  <Words>106</Words>
  <Application>Microsoft Macintosh PowerPoint</Application>
  <PresentationFormat>On-screen Show (4:3)</PresentationFormat>
  <Paragraphs>5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Symbol</vt:lpstr>
      <vt:lpstr>Arial</vt:lpstr>
      <vt:lpstr>Office Theme</vt:lpstr>
      <vt:lpstr>PowerPoint Presentation</vt:lpstr>
    </vt:vector>
  </TitlesOfParts>
  <Company>NIH</Company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a Annunziata</dc:creator>
  <cp:lastModifiedBy>Carrie House</cp:lastModifiedBy>
  <cp:revision>358</cp:revision>
  <dcterms:created xsi:type="dcterms:W3CDTF">2016-03-03T15:39:21Z</dcterms:created>
  <dcterms:modified xsi:type="dcterms:W3CDTF">2018-05-09T15:06:16Z</dcterms:modified>
</cp:coreProperties>
</file>